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</a:t>
            </a:r>
            <a:r>
              <a:rPr lang="en-US" altLang="zh-CN" baseline="0" dirty="0"/>
              <a:t>e S2 </a:t>
            </a:r>
            <a:r>
              <a:rPr lang="en-US" altLang="zh-CN" i="1" baseline="0" dirty="0"/>
              <a:t>atrnh1b</a:t>
            </a:r>
            <a:r>
              <a:rPr lang="en-US" altLang="zh-CN" baseline="0" dirty="0"/>
              <a:t> mutants have no obvious phenotype in normal conditions. (A) gene structure of </a:t>
            </a:r>
            <a:r>
              <a:rPr lang="en-US" altLang="zh-CN" i="1" baseline="0" dirty="0"/>
              <a:t>AtRNH1B</a:t>
            </a:r>
            <a:r>
              <a:rPr lang="en-US" altLang="zh-CN" baseline="0" dirty="0"/>
              <a:t> genomic DNA. White boxes represent </a:t>
            </a:r>
            <a:r>
              <a:rPr lang="en-US" altLang="zh-CN" baseline="0" dirty="0" err="1"/>
              <a:t>utr</a:t>
            </a:r>
            <a:r>
              <a:rPr lang="en-US" altLang="zh-CN" baseline="0" dirty="0"/>
              <a:t>, black boxes represent exon. The triangles  point to the positions of T-DNA insertions. </a:t>
            </a:r>
            <a:r>
              <a:rPr lang="en-US" altLang="zh-CN" i="1" baseline="0" dirty="0"/>
              <a:t>atrnh1b-1</a:t>
            </a:r>
            <a:r>
              <a:rPr lang="en-US" altLang="zh-CN" baseline="0" dirty="0"/>
              <a:t> is inserted into the second exon and </a:t>
            </a:r>
            <a:r>
              <a:rPr lang="en-US" altLang="zh-CN" i="1" baseline="0" dirty="0"/>
              <a:t>atrnh1b-2</a:t>
            </a:r>
            <a:r>
              <a:rPr lang="en-US" altLang="zh-CN" baseline="0" dirty="0"/>
              <a:t> is inserted to the sixth intron. (B and C) 28cycles RT-PCR of </a:t>
            </a:r>
            <a:r>
              <a:rPr lang="en-US" altLang="zh-CN" i="1" baseline="0" dirty="0"/>
              <a:t>AtRNH1B</a:t>
            </a:r>
            <a:r>
              <a:rPr lang="en-US" altLang="zh-CN" baseline="0" dirty="0"/>
              <a:t> transcript in atrnh1b-1 (B) and atrnh1b-2 (C), primers were shown in A, </a:t>
            </a:r>
            <a:r>
              <a:rPr lang="en-US" altLang="zh-CN" i="1" baseline="0" dirty="0"/>
              <a:t>GAPDH</a:t>
            </a:r>
            <a:r>
              <a:rPr lang="en-US" altLang="zh-CN" baseline="0" dirty="0"/>
              <a:t> is the reference gene. (D and E) the plants of Col-0 and </a:t>
            </a:r>
            <a:r>
              <a:rPr lang="en-US" altLang="zh-CN" i="1" baseline="0" dirty="0"/>
              <a:t>atrnh1b</a:t>
            </a:r>
            <a:r>
              <a:rPr lang="en-US" altLang="zh-CN" baseline="0" dirty="0"/>
              <a:t> mutants in vegetative stage and reproductive stage.  Bar= 1cm. 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20CCCD-B101-4F1D-9219-C57E8989889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65788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microsoft.com/office/2007/relationships/hdphoto" Target="../media/hdphoto3.wdp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2516" y="3046181"/>
            <a:ext cx="2932430" cy="189602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7940" y="2095654"/>
            <a:ext cx="2932430" cy="920576"/>
          </a:xfrm>
          <a:prstGeom prst="rect">
            <a:avLst/>
          </a:prstGeom>
        </p:spPr>
      </p:pic>
      <p:grpSp>
        <p:nvGrpSpPr>
          <p:cNvPr id="20" name="组合 19"/>
          <p:cNvGrpSpPr/>
          <p:nvPr/>
        </p:nvGrpSpPr>
        <p:grpSpPr>
          <a:xfrm>
            <a:off x="1694310" y="1018428"/>
            <a:ext cx="1666842" cy="835983"/>
            <a:chOff x="1579277" y="1592455"/>
            <a:chExt cx="1666842" cy="835983"/>
          </a:xfrm>
        </p:grpSpPr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b="27648"/>
            <a:stretch/>
          </p:blipFill>
          <p:spPr>
            <a:xfrm>
              <a:off x="2146098" y="1923857"/>
              <a:ext cx="758598" cy="209513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/>
          </p:nvSpPr>
          <p:spPr>
            <a:xfrm rot="18973019">
              <a:off x="2521436" y="1592455"/>
              <a:ext cx="7246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nh1b-1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 rot="19118044">
              <a:off x="2146434" y="1686411"/>
              <a:ext cx="4677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579277" y="2212994"/>
              <a:ext cx="6247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631834" y="1932670"/>
              <a:ext cx="5721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1+P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3529528" y="1017217"/>
            <a:ext cx="1643845" cy="843313"/>
            <a:chOff x="2939976" y="1584409"/>
            <a:chExt cx="1643845" cy="843313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11658" b="16862"/>
            <a:stretch/>
          </p:blipFill>
          <p:spPr>
            <a:xfrm>
              <a:off x="3496522" y="1923849"/>
              <a:ext cx="759600" cy="209219"/>
            </a:xfrm>
            <a:prstGeom prst="rect">
              <a:avLst/>
            </a:prstGeom>
          </p:spPr>
        </p:pic>
        <p:sp>
          <p:nvSpPr>
            <p:cNvPr id="31" name="文本框 30"/>
            <p:cNvSpPr txBox="1"/>
            <p:nvPr/>
          </p:nvSpPr>
          <p:spPr>
            <a:xfrm rot="18973019">
              <a:off x="3859138" y="1584409"/>
              <a:ext cx="7246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nh1b-2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 rot="19118044">
              <a:off x="3484136" y="1678365"/>
              <a:ext cx="4677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2939976" y="2212278"/>
              <a:ext cx="606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2992533" y="1931954"/>
              <a:ext cx="5543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3+P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5" name="直接连接符 44"/>
          <p:cNvCxnSpPr/>
          <p:nvPr/>
        </p:nvCxnSpPr>
        <p:spPr>
          <a:xfrm>
            <a:off x="4391265" y="4802252"/>
            <a:ext cx="26055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4315231" y="4621767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zh-CN" alt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  <a:endParaRPr lang="zh-CN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4352670" y="2940771"/>
            <a:ext cx="32118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1996299" y="1891492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905600" y="1891492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trnh1b-1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907294" y="1891492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trnh1b-2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1485003" y="25387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1485003" y="9968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468331" y="9976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1485003" y="187587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34DC1DF5-B50C-4C30-BFD5-9E05262552EA}"/>
              </a:ext>
            </a:extLst>
          </p:cNvPr>
          <p:cNvGrpSpPr/>
          <p:nvPr/>
        </p:nvGrpSpPr>
        <p:grpSpPr>
          <a:xfrm>
            <a:off x="1498396" y="335414"/>
            <a:ext cx="4062690" cy="617884"/>
            <a:chOff x="1469367" y="959528"/>
            <a:chExt cx="4062690" cy="617884"/>
          </a:xfrm>
        </p:grpSpPr>
        <p:sp>
          <p:nvSpPr>
            <p:cNvPr id="6" name="文本框 5"/>
            <p:cNvSpPr txBox="1"/>
            <p:nvPr/>
          </p:nvSpPr>
          <p:spPr>
            <a:xfrm>
              <a:off x="2453045" y="1355777"/>
              <a:ext cx="311304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图片 6"/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2216"/>
            <a:stretch/>
          </p:blipFill>
          <p:spPr>
            <a:xfrm>
              <a:off x="2027498" y="1224964"/>
              <a:ext cx="3407559" cy="137562"/>
            </a:xfrm>
            <a:prstGeom prst="rect">
              <a:avLst/>
            </a:prstGeom>
          </p:spPr>
        </p:pic>
        <p:sp>
          <p:nvSpPr>
            <p:cNvPr id="8" name="等腰三角形 7"/>
            <p:cNvSpPr/>
            <p:nvPr/>
          </p:nvSpPr>
          <p:spPr>
            <a:xfrm flipV="1">
              <a:off x="3191263" y="1137181"/>
              <a:ext cx="87726" cy="10203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肘形连接符 8"/>
            <p:cNvCxnSpPr/>
            <p:nvPr/>
          </p:nvCxnSpPr>
          <p:spPr>
            <a:xfrm flipV="1">
              <a:off x="2407780" y="1124489"/>
              <a:ext cx="239659" cy="118967"/>
            </a:xfrm>
            <a:prstGeom prst="bentConnector3">
              <a:avLst/>
            </a:prstGeom>
            <a:ln>
              <a:solidFill>
                <a:srgbClr val="6E6E6E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/>
          </p:nvSpPr>
          <p:spPr>
            <a:xfrm>
              <a:off x="3023765" y="959528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hn1b-1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直接箭头连接符 10"/>
            <p:cNvCxnSpPr/>
            <p:nvPr/>
          </p:nvCxnSpPr>
          <p:spPr>
            <a:xfrm>
              <a:off x="2560936" y="1375215"/>
              <a:ext cx="864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箭头连接符 11"/>
            <p:cNvCxnSpPr/>
            <p:nvPr/>
          </p:nvCxnSpPr>
          <p:spPr>
            <a:xfrm flipH="1">
              <a:off x="4856249" y="1382873"/>
              <a:ext cx="8509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箭头连接符 12"/>
            <p:cNvCxnSpPr/>
            <p:nvPr/>
          </p:nvCxnSpPr>
          <p:spPr>
            <a:xfrm flipH="1">
              <a:off x="3350338" y="1375637"/>
              <a:ext cx="8509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13"/>
            <p:cNvSpPr txBox="1"/>
            <p:nvPr/>
          </p:nvSpPr>
          <p:spPr>
            <a:xfrm>
              <a:off x="4743144" y="1361967"/>
              <a:ext cx="311304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237913" y="1352102"/>
              <a:ext cx="311304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等腰三角形 15"/>
            <p:cNvSpPr/>
            <p:nvPr/>
          </p:nvSpPr>
          <p:spPr>
            <a:xfrm flipV="1">
              <a:off x="4697113" y="1144381"/>
              <a:ext cx="87726" cy="102032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521961" y="959528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hn1b-2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直接箭头连接符 3"/>
            <p:cNvCxnSpPr/>
            <p:nvPr/>
          </p:nvCxnSpPr>
          <p:spPr>
            <a:xfrm>
              <a:off x="4479663" y="1379256"/>
              <a:ext cx="8509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4"/>
            <p:cNvSpPr txBox="1"/>
            <p:nvPr/>
          </p:nvSpPr>
          <p:spPr>
            <a:xfrm>
              <a:off x="4366558" y="1360041"/>
              <a:ext cx="3113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3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469367" y="1183119"/>
              <a:ext cx="6447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NH1B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直接连接符 54"/>
            <p:cNvCxnSpPr/>
            <p:nvPr/>
          </p:nvCxnSpPr>
          <p:spPr>
            <a:xfrm>
              <a:off x="5233151" y="1514286"/>
              <a:ext cx="1548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/>
            <p:cNvSpPr txBox="1"/>
            <p:nvPr/>
          </p:nvSpPr>
          <p:spPr>
            <a:xfrm>
              <a:off x="5130985" y="1352095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4" name="图片 53"/>
          <p:cNvPicPr>
            <a:picLocks noChangeAspect="1"/>
          </p:cNvPicPr>
          <p:nvPr/>
        </p:nvPicPr>
        <p:blipFill>
          <a:blip r:embed="rId10" cstate="hq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0118" y="1597563"/>
            <a:ext cx="759600" cy="268234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137" y="1630747"/>
            <a:ext cx="759600" cy="21955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8983DA3-C253-7A40-9BCE-C8BCA729250A}"/>
              </a:ext>
            </a:extLst>
          </p:cNvPr>
          <p:cNvSpPr/>
          <p:nvPr/>
        </p:nvSpPr>
        <p:spPr>
          <a:xfrm>
            <a:off x="553357" y="5502202"/>
            <a:ext cx="6123214" cy="19141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2 Fig. </a:t>
            </a:r>
            <a:r>
              <a:rPr lang="en-US" sz="1000" b="1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mutants have no obvious phenotype.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endParaRPr lang="en-CN" sz="12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Gene structure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genomic DNA. White boxes represent UTRs, black boxes represent exons, and black lines represent introns. The triangles point to the positions of T-DNA insertions in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2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(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B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and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) 28 cycles of RT-PCR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transcript in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B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2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C)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; primers are shown in A.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GAPDH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was used as the reference gene.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D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Col-0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plants at the vegetative stage (upper) and reproductive stage (bottom). Scale bars, 1 cm. The data underlying this figure can be found in S1 Raw Images. UTRs, untranslated regions; RT-PCR, reverse transcription PCR.</a:t>
            </a:r>
            <a:endParaRPr lang="en-CN" sz="12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1023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36</TotalTime>
  <Words>279</Words>
  <Application>Microsoft Macintosh PowerPoint</Application>
  <PresentationFormat>A4 Paper (210x297 mm)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234</cp:revision>
  <cp:lastPrinted>2020-08-24T06:21:32Z</cp:lastPrinted>
  <dcterms:created xsi:type="dcterms:W3CDTF">2019-11-01T09:30:31Z</dcterms:created>
  <dcterms:modified xsi:type="dcterms:W3CDTF">2021-07-12T09:49:50Z</dcterms:modified>
</cp:coreProperties>
</file>